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516" y="30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138D84A-F941-4C2D-99FA-B9E8B8B18C6D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F9294C5-71AA-4AE7-918D-960BB6443C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67504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F9294C5-71AA-4AE7-918D-960BB6443C5B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24147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/>
        </p:nvGraphicFramePr>
        <p:xfrm>
          <a:off x="684213" y="1139825"/>
          <a:ext cx="7775580" cy="4178310"/>
        </p:xfrm>
        <a:graphic>
          <a:graphicData uri="http://schemas.openxmlformats.org/drawingml/2006/table">
            <a:tbl>
              <a:tblPr/>
              <a:tblGrid>
                <a:gridCol w="518372"/>
                <a:gridCol w="572676"/>
                <a:gridCol w="464068"/>
                <a:gridCol w="518372"/>
                <a:gridCol w="518372"/>
                <a:gridCol w="518372"/>
                <a:gridCol w="518372"/>
                <a:gridCol w="518372"/>
                <a:gridCol w="518372"/>
                <a:gridCol w="518372"/>
                <a:gridCol w="518372"/>
                <a:gridCol w="518372"/>
                <a:gridCol w="518372"/>
                <a:gridCol w="518372"/>
                <a:gridCol w="518372"/>
              </a:tblGrid>
              <a:tr h="145046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air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ampl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ha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uc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ra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Xyl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a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lu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al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Xyl</a:t>
                      </a: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/</a:t>
                      </a:r>
                      <a:r>
                        <a:rPr lang="en-US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ra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zh-CN" alt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5359" marR="35359" marT="17680" marB="1768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5359" marR="35359" marT="17680" marB="1768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zh-CN" alt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5359" marR="35359" marT="17680" marB="1768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zh-CN" alt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5359" marR="35359" marT="17680" marB="1768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zh-CN" alt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5359" marR="35359" marT="17680" marB="1768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1490"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5359" marR="35359" marT="17680" marB="176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5359" marR="35359" marT="17680" marB="176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5359" marR="35359" marT="17680" marB="176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5359" marR="35359" marT="17680" marB="176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5359" marR="35359" marT="17680" marB="176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5359" marR="35359" marT="17680" marB="176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5359" marR="35359" marT="17680" marB="176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5359" marR="35359" marT="17680" marB="176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5359" marR="35359" marT="17680" marB="1768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KOH-extractabl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zh-CN" alt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5359" marR="35359" marT="17680" marB="1768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on-KOH-extractabl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zh-CN" alt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5359" marR="35359" marT="17680" marB="1768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otal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zh-CN" alt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5359" marR="35359" marT="17680" marB="1768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5046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-1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aLq27(H</a:t>
                      </a:r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)</a:t>
                      </a:r>
                      <a:r>
                        <a:rPr kumimoji="0" lang="zh-CN" altLang="en-US" sz="12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sym typeface="宋体" pitchFamily="2" charset="-122"/>
                        </a:rPr>
                        <a:t>&amp;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3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.85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8.97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5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5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5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.3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.7%</a:t>
                      </a:r>
                      <a:r>
                        <a:rPr lang="en-US" altLang="zh-CN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*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6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8.0%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.1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2%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45046"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aLq98(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4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.75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9.07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2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9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02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.7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.4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.2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1937"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046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-2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aLq1(H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8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.07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8.72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1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8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03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.9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6%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1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9.4%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.8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6%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046"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aLq47(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1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.86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8.90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4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2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08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.1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.3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.0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1937"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83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-3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aLq107(H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9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.57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7.46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3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21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34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.3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.1%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2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9.7%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.1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0.6%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046"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aLq93(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0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.15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9.77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2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9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8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.3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.8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.0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1937"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1937"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046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I-1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aLq1(H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8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.07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8.72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1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8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03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.9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.9%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1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1.0%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.8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6.6%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046"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aLq71(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8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.91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0.18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3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9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1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.5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.2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.4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1937"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83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I-2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aLq107(H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9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.57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7.46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3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21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34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.3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.6%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2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7.2%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.1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3.4%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046"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aLq58(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8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.97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9.82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4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2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7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.2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.1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.3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1937"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046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I-3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aLq46(H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8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.72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7.43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3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8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47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.8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9%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2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.4%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.0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1.6%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046"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aLq47(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1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.86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8.90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4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2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08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.1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.3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.0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1937"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1937"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046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II-1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Osfc27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H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0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.63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0.45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8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31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33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.3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5.9%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5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8.1%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.4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9.0%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046"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aLq71(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8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.91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0.18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3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9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1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.5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.2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.4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1937"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046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II-2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Osfc2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H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6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.60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9.94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8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.29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83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.5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4.1%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9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0.4%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.9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5.0%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046"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aLq85(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1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.89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8.85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3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3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8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.9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.0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.0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1937"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046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II-3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Osfc32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H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6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1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.28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1.48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0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.89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97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.5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6.8%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7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7.3%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.6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1.6%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5046"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aLq27(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3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.85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8.97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5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5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5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%</a:t>
                      </a:r>
                      <a:r>
                        <a:rPr lang="en-US" altLang="zh-CN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.3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6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.1 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1662" name="Rectangle 1104"/>
          <p:cNvSpPr>
            <a:spLocks noGrp="1" noChangeArrowheads="1"/>
          </p:cNvSpPr>
          <p:nvPr>
            <p:ph type="title" idx="4294967295"/>
          </p:nvPr>
        </p:nvSpPr>
        <p:spPr>
          <a:xfrm>
            <a:off x="611188" y="909638"/>
            <a:ext cx="5976937" cy="215900"/>
          </a:xfrm>
        </p:spPr>
        <p:txBody>
          <a:bodyPr>
            <a:noAutofit/>
          </a:bodyPr>
          <a:lstStyle/>
          <a:p>
            <a:pPr algn="l"/>
            <a:r>
              <a:rPr lang="zh-CN" altLang="en-US" sz="1000" b="1" dirty="0" smtClean="0">
                <a:latin typeface="Arial" pitchFamily="34" charset="0"/>
                <a:cs typeface="Arial" pitchFamily="34" charset="0"/>
              </a:rPr>
              <a:t>Table S</a:t>
            </a: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4. </a:t>
            </a:r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Monosaccharide composition of hemicelluloses (%</a:t>
            </a:r>
            <a:r>
              <a:rPr lang="zh-CN" altLang="en-US" sz="1000" dirty="0" smtClean="0">
                <a:latin typeface="Arial" pitchFamily="34" charset="0"/>
                <a:cs typeface="Arial" pitchFamily="34" charset="0"/>
              </a:rPr>
              <a:t>)</a:t>
            </a:r>
          </a:p>
        </p:txBody>
      </p:sp>
      <p:sp>
        <p:nvSpPr>
          <p:cNvPr id="11663" name="Rectangle 1105"/>
          <p:cNvSpPr>
            <a:spLocks noChangeArrowheads="1"/>
          </p:cNvSpPr>
          <p:nvPr/>
        </p:nvSpPr>
        <p:spPr bwMode="auto">
          <a:xfrm>
            <a:off x="587375" y="5303838"/>
            <a:ext cx="7945438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GB" altLang="en-US" sz="1400" b="1" baseline="30000" dirty="0">
                <a:latin typeface="Arial" pitchFamily="34" charset="0"/>
                <a:cs typeface="Arial" pitchFamily="34" charset="0"/>
                <a:sym typeface="宋体" pitchFamily="2" charset="-122"/>
              </a:rPr>
              <a:t>&amp;</a:t>
            </a:r>
            <a:r>
              <a:rPr lang="en-US" altLang="zh-CN" sz="1000" baseline="0" dirty="0">
                <a:latin typeface="Arial" pitchFamily="34" charset="0"/>
                <a:cs typeface="Arial" pitchFamily="34" charset="0"/>
                <a:sym typeface="宋体" pitchFamily="2" charset="-122"/>
              </a:rPr>
              <a:t>,</a:t>
            </a:r>
            <a:r>
              <a:rPr lang="zh-CN" altLang="en-US" sz="1000" baseline="0" dirty="0">
                <a:latin typeface="Arial" pitchFamily="34" charset="0"/>
                <a:cs typeface="Arial" pitchFamily="34" charset="0"/>
                <a:sym typeface="宋体" pitchFamily="2" charset="-122"/>
              </a:rPr>
              <a:t> (H) or (L) Indicated the sample in the pair with high (H) or low (L)  biomass digestibility</a:t>
            </a:r>
            <a:r>
              <a:rPr lang="en-US" altLang="zh-CN" sz="1000" baseline="0" dirty="0">
                <a:latin typeface="Arial" pitchFamily="34" charset="0"/>
                <a:cs typeface="Arial" pitchFamily="34" charset="0"/>
                <a:sym typeface="宋体" pitchFamily="2" charset="-122"/>
              </a:rPr>
              <a:t>;</a:t>
            </a:r>
            <a:endParaRPr lang="zh-CN" altLang="en-US" sz="1000" baseline="0" dirty="0">
              <a:latin typeface="Arial" pitchFamily="34" charset="0"/>
              <a:cs typeface="Arial" pitchFamily="34" charset="0"/>
              <a:sym typeface="宋体" pitchFamily="2" charset="-122"/>
            </a:endParaRPr>
          </a:p>
          <a:p>
            <a:r>
              <a:rPr lang="zh-CN" altLang="en-US" sz="1400" b="1" baseline="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*</a:t>
            </a:r>
            <a:r>
              <a:rPr lang="en-US" altLang="zh-CN" sz="1000" baseline="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, </a:t>
            </a:r>
            <a:r>
              <a:rPr lang="en-GB" altLang="zh-CN" sz="1000" baseline="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GB" altLang="zh-CN" sz="1000" baseline="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P</a:t>
            </a:r>
            <a:r>
              <a:rPr lang="en-GB" altLang="en-US" sz="1000" baseline="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ercentage of the increased or decreased level at pair: subtraction of two samples divided by </a:t>
            </a:r>
            <a:r>
              <a:rPr lang="zh-CN" altLang="en-US" sz="1000" baseline="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low </a:t>
            </a:r>
            <a:r>
              <a:rPr lang="en-GB" altLang="en-US" sz="1000" baseline="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value at </a:t>
            </a:r>
            <a:r>
              <a:rPr lang="en-GB" altLang="zh-CN" sz="1000" baseline="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pair</a:t>
            </a:r>
            <a:r>
              <a:rPr lang="zh-CN" altLang="en-US" sz="1000" baseline="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9024010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87</Words>
  <Application>Microsoft Office PowerPoint</Application>
  <PresentationFormat>全屏显示(4:3)</PresentationFormat>
  <Paragraphs>245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Table S4. Monosaccharide composition of hemicelluloses (%)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able S4. Monosaccharide composition of hemicelluloses (%)</dc:title>
  <cp:lastModifiedBy>微软用户</cp:lastModifiedBy>
  <cp:revision>4</cp:revision>
  <dcterms:modified xsi:type="dcterms:W3CDTF">2013-09-04T07:30:40Z</dcterms:modified>
</cp:coreProperties>
</file>